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Default Extension="svg" ContentType="image/svg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Default Extension="tiff" ContentType="image/tiff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Override PartName="/ppt/slides/slide5.xml" ContentType="application/vnd.openxmlformats-officedocument.presentationml.slide+xml"/>
  <Override PartName="/ppt/slides/slide19.xml" ContentType="application/vnd.openxmlformats-officedocument.presentationml.slide+xml"/>
  <Override PartName="/ppt/slides/slide28.xml" ContentType="application/vnd.openxmlformats-officedocument.presentationml.slide+xml"/>
  <Override PartName="/ppt/slideLayouts/slideLayout7.xml" ContentType="application/vnd.openxmlformats-officedocument.presentationml.slideLayout+xml"/>
  <Default Extension="png" ContentType="image/png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57" r:id="rId3"/>
    <p:sldId id="258" r:id="rId4"/>
    <p:sldId id="259" r:id="rId5"/>
    <p:sldId id="278" r:id="rId6"/>
    <p:sldId id="260" r:id="rId7"/>
    <p:sldId id="261" r:id="rId8"/>
    <p:sldId id="262" r:id="rId9"/>
    <p:sldId id="263" r:id="rId10"/>
    <p:sldId id="264" r:id="rId11"/>
    <p:sldId id="279" r:id="rId12"/>
    <p:sldId id="265" r:id="rId13"/>
    <p:sldId id="267" r:id="rId14"/>
    <p:sldId id="266" r:id="rId15"/>
    <p:sldId id="276" r:id="rId16"/>
    <p:sldId id="277" r:id="rId17"/>
    <p:sldId id="280" r:id="rId18"/>
    <p:sldId id="274" r:id="rId19"/>
    <p:sldId id="269" r:id="rId20"/>
    <p:sldId id="271" r:id="rId21"/>
    <p:sldId id="270" r:id="rId22"/>
    <p:sldId id="272" r:id="rId23"/>
    <p:sldId id="281" r:id="rId24"/>
    <p:sldId id="273" r:id="rId25"/>
    <p:sldId id="282" r:id="rId26"/>
    <p:sldId id="284" r:id="rId27"/>
    <p:sldId id="285" r:id="rId28"/>
    <p:sldId id="283" r:id="rId29"/>
  </p:sldIdLst>
  <p:sldSz cx="12192000" cy="6858000"/>
  <p:notesSz cx="7099300" cy="102346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7" d="100"/>
          <a:sy n="87" d="100"/>
        </p:scale>
        <p:origin x="-470" y="-8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25/5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25/5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25/5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25/5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25/5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25/5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25/5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25/5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25/5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25/5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pPr/>
              <a:t>2025/5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pPr/>
              <a:t>2025/5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tiff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sv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5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tiff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8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tiff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8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31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2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8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6.tiff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tiff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8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39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0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4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4.svg"/><Relationship Id="rId4" Type="http://schemas.openxmlformats.org/officeDocument/2006/relationships/image" Target="../media/image42.pn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tiff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8.png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png"/><Relationship Id="rId2" Type="http://schemas.openxmlformats.org/officeDocument/2006/relationships/image" Target="../media/image45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8.png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tiff"/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8.png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tiff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8.png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tiff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3.png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png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5.tiff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png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7.tiff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png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9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f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F596F69D-796D-4E33-8D31-05006077DD76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4419216" y="543470"/>
            <a:ext cx="7577475" cy="1997077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C15C38A3-4313-4D53-B0E8-53241718C35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 flipV="1">
            <a:off x="5451231" y="2644664"/>
            <a:ext cx="6545460" cy="1760779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xmlns="" id="{CEC1A132-D15D-46EF-82A2-4BA42FB72F4E}"/>
              </a:ext>
            </a:extLst>
          </p:cNvPr>
          <p:cNvSpPr txBox="1"/>
          <p:nvPr/>
        </p:nvSpPr>
        <p:spPr>
          <a:xfrm>
            <a:off x="59971" y="119555"/>
            <a:ext cx="22604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F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xmlns="" id="{B5BE91D1-0761-476D-BE49-056DDC3A13E2}"/>
              </a:ext>
            </a:extLst>
          </p:cNvPr>
          <p:cNvSpPr txBox="1"/>
          <p:nvPr/>
        </p:nvSpPr>
        <p:spPr>
          <a:xfrm>
            <a:off x="5052874" y="119555"/>
            <a:ext cx="20862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data of KIF14 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xmlns="" id="{7583B879-F21D-7331-00AC-37A7DD779506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33957" y="545928"/>
            <a:ext cx="4355321" cy="36900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196829903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FA9F8F9E-AFA8-43E3-B005-20F0D5BF831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 flipH="1">
            <a:off x="4817666" y="2555684"/>
            <a:ext cx="6754062" cy="1262383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61DB8210-84C2-41F3-A5B8-46308E028C15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5563363" y="594307"/>
            <a:ext cx="6067358" cy="1634272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xmlns="" id="{88B39B5A-515A-460F-8CF6-8296FD4F2140}"/>
              </a:ext>
            </a:extLst>
          </p:cNvPr>
          <p:cNvSpPr txBox="1"/>
          <p:nvPr/>
        </p:nvSpPr>
        <p:spPr>
          <a:xfrm>
            <a:off x="5520430" y="26971"/>
            <a:ext cx="29459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data of P27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xmlns="" id="{381AF9FE-8366-4B20-AEC2-BA820D2FC787}"/>
              </a:ext>
            </a:extLst>
          </p:cNvPr>
          <p:cNvSpPr txBox="1"/>
          <p:nvPr/>
        </p:nvSpPr>
        <p:spPr>
          <a:xfrm>
            <a:off x="20844" y="26971"/>
            <a:ext cx="22604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F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xmlns="" id="{5613E11B-5C20-CCB1-FA43-C8762AE7F3C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33957" y="531180"/>
            <a:ext cx="4355321" cy="36900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26665379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xmlns="" id="{E214B8AD-28C1-4414-873B-5DF1D1F0DCC9}"/>
              </a:ext>
            </a:extLst>
          </p:cNvPr>
          <p:cNvSpPr txBox="1"/>
          <p:nvPr/>
        </p:nvSpPr>
        <p:spPr>
          <a:xfrm>
            <a:off x="20844" y="26971"/>
            <a:ext cx="22604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F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9AFFFCDA-C562-4E00-B1FE-E63A0221008C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5033482" y="990389"/>
            <a:ext cx="5769530" cy="2438611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A5C25CF3-DFF3-416E-9E08-A065BDDC38F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 flipV="1">
            <a:off x="5689475" y="3768064"/>
            <a:ext cx="5113537" cy="2344858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xmlns="" id="{8B7D3875-453E-AD85-C0A0-C5D452536D2F}"/>
              </a:ext>
            </a:extLst>
          </p:cNvPr>
          <p:cNvSpPr txBox="1"/>
          <p:nvPr/>
        </p:nvSpPr>
        <p:spPr>
          <a:xfrm>
            <a:off x="5857782" y="81778"/>
            <a:ext cx="29459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data of MMP-2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xmlns="" id="{F3627FC3-10D0-719F-B421-DD05527FA61F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94628" y="536096"/>
            <a:ext cx="4355321" cy="36900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414867066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形 3">
            <a:extLst>
              <a:ext uri="{FF2B5EF4-FFF2-40B4-BE49-F238E27FC236}">
                <a16:creationId xmlns:a16="http://schemas.microsoft.com/office/drawing/2014/main" xmlns="" id="{DAED95AC-8624-4F38-8D5E-C6E93013469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96DAC541-7B7A-43D3-8B79-37D633B846F1}">
                <asvg:svgBlip xmlns:asvg="http://schemas.microsoft.com/office/drawing/2016/SVG/main" xmlns="" r:embed="rId3"/>
              </a:ext>
            </a:extLst>
          </a:blip>
          <a:stretch>
            <a:fillRect/>
          </a:stretch>
        </p:blipFill>
        <p:spPr>
          <a:xfrm>
            <a:off x="6802118" y="2929912"/>
            <a:ext cx="5034107" cy="125591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xmlns="" id="{357D7F72-08CD-441D-BCCA-9022D21440AF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6096000" y="568228"/>
            <a:ext cx="5949935" cy="1535779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xmlns="" id="{0980B490-C24D-462E-8E32-CDC9CC6453D7}"/>
              </a:ext>
            </a:extLst>
          </p:cNvPr>
          <p:cNvSpPr txBox="1"/>
          <p:nvPr/>
        </p:nvSpPr>
        <p:spPr>
          <a:xfrm>
            <a:off x="5857782" y="81778"/>
            <a:ext cx="29459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data of β-actin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xmlns="" id="{9C08160C-1617-465F-83CC-9079B6697FF4}"/>
              </a:ext>
            </a:extLst>
          </p:cNvPr>
          <p:cNvSpPr txBox="1"/>
          <p:nvPr/>
        </p:nvSpPr>
        <p:spPr>
          <a:xfrm>
            <a:off x="20844" y="26971"/>
            <a:ext cx="22604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F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xmlns="" id="{B7C98B0D-8E1E-01A6-3A29-B62BA8DF44BF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19208" y="568228"/>
            <a:ext cx="4355321" cy="36900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147670470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AB0CF8D5-3FEA-4BD2-93DE-63FAC3F60205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4811697" y="666623"/>
            <a:ext cx="7590408" cy="1805278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EE83A3F1-B61F-457B-9CD2-F487600ADBA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 flipV="1">
            <a:off x="5550023" y="2594498"/>
            <a:ext cx="4957734" cy="1669002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xmlns="" id="{F0D7A8E5-4B4A-49D9-92BB-F4D0F896980A}"/>
              </a:ext>
            </a:extLst>
          </p:cNvPr>
          <p:cNvSpPr txBox="1"/>
          <p:nvPr/>
        </p:nvSpPr>
        <p:spPr>
          <a:xfrm>
            <a:off x="20844" y="26971"/>
            <a:ext cx="22604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7D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xmlns="" id="{3A5A67A8-E660-4B70-9A34-747F7D414D9F}"/>
              </a:ext>
            </a:extLst>
          </p:cNvPr>
          <p:cNvSpPr txBox="1"/>
          <p:nvPr/>
        </p:nvSpPr>
        <p:spPr>
          <a:xfrm>
            <a:off x="5550023" y="26971"/>
            <a:ext cx="20862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data of KIF14 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87A0711E-BF0E-4875-8462-45AAE300B470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0" y="557472"/>
            <a:ext cx="4509586" cy="40740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70575549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D79FBEDC-6511-4016-96DB-476A5257379D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4468556" y="816841"/>
            <a:ext cx="7503504" cy="1562373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F4246A2D-7045-47CB-A70D-9282DAB0776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 flipV="1">
            <a:off x="5102057" y="2723228"/>
            <a:ext cx="5585122" cy="1906479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xmlns="" id="{303B3525-DF69-4D36-9EC4-4CA810EB5179}"/>
              </a:ext>
            </a:extLst>
          </p:cNvPr>
          <p:cNvSpPr txBox="1"/>
          <p:nvPr/>
        </p:nvSpPr>
        <p:spPr>
          <a:xfrm>
            <a:off x="5052677" y="134273"/>
            <a:ext cx="36030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data of p-AKT(Ser473)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xmlns="" id="{F60648E0-964E-434C-9080-D1DCD0CF14A1}"/>
              </a:ext>
            </a:extLst>
          </p:cNvPr>
          <p:cNvSpPr txBox="1"/>
          <p:nvPr/>
        </p:nvSpPr>
        <p:spPr>
          <a:xfrm>
            <a:off x="0" y="0"/>
            <a:ext cx="22604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7D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xmlns="" id="{4A8AD7F0-F39A-45B6-B925-ED6C9A4E9BE4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88776" y="555654"/>
            <a:ext cx="4509586" cy="40740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81400740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9A62D140-2D02-4254-AFB8-78CD1DC6FD5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 flipV="1">
            <a:off x="5514302" y="2688308"/>
            <a:ext cx="6450060" cy="1496829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xmlns="" id="{8E64D625-D70F-41F4-936C-B09DD117A69E}"/>
              </a:ext>
            </a:extLst>
          </p:cNvPr>
          <p:cNvSpPr txBox="1"/>
          <p:nvPr/>
        </p:nvSpPr>
        <p:spPr>
          <a:xfrm>
            <a:off x="5052677" y="134273"/>
            <a:ext cx="36030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data of AKT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xmlns="" id="{11B1F754-7318-438F-B892-85CB1F3327E8}"/>
              </a:ext>
            </a:extLst>
          </p:cNvPr>
          <p:cNvSpPr txBox="1"/>
          <p:nvPr/>
        </p:nvSpPr>
        <p:spPr>
          <a:xfrm>
            <a:off x="0" y="0"/>
            <a:ext cx="22604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7D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xmlns="" id="{1CDFC945-161A-4F98-98E8-41C9A3E72A25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88776" y="555654"/>
            <a:ext cx="4509586" cy="4074053"/>
          </a:xfrm>
          <a:prstGeom prst="rect">
            <a:avLst/>
          </a:prstGeom>
        </p:spPr>
      </p:pic>
      <p:pic>
        <p:nvPicPr>
          <p:cNvPr id="9" name="图片 8" descr="微信图片_20250512214221.png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4632612" y="667111"/>
            <a:ext cx="6656712" cy="19019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178074288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AD501D7C-1F2A-4C01-8C8B-017AF100305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833288" y="2862002"/>
            <a:ext cx="5718699" cy="1559645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79BAA26A-DE75-494D-BA4D-07CF21E8CA4A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5032668" y="721563"/>
            <a:ext cx="7023208" cy="1457097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xmlns="" id="{89F8ADF9-3A2D-42E1-BD29-9C72CA11B549}"/>
              </a:ext>
            </a:extLst>
          </p:cNvPr>
          <p:cNvSpPr txBox="1"/>
          <p:nvPr/>
        </p:nvSpPr>
        <p:spPr>
          <a:xfrm>
            <a:off x="5052677" y="134273"/>
            <a:ext cx="36030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data of P27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xmlns="" id="{F6CF25A7-9500-48C7-869C-94BE4B9FA095}"/>
              </a:ext>
            </a:extLst>
          </p:cNvPr>
          <p:cNvSpPr txBox="1"/>
          <p:nvPr/>
        </p:nvSpPr>
        <p:spPr>
          <a:xfrm>
            <a:off x="0" y="0"/>
            <a:ext cx="22604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7D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xmlns="" id="{38518B4A-0F57-4B54-8069-37CB9F965E51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88776" y="555654"/>
            <a:ext cx="4509586" cy="40740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329432487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xmlns="" id="{9295386F-4FFC-44B4-8B21-382B996CB9DC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47769" y="619564"/>
            <a:ext cx="4509586" cy="4074053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xmlns="" id="{3C8B6082-F0B9-4E0E-A29B-394694D3DE5D}"/>
              </a:ext>
            </a:extLst>
          </p:cNvPr>
          <p:cNvSpPr txBox="1"/>
          <p:nvPr/>
        </p:nvSpPr>
        <p:spPr>
          <a:xfrm>
            <a:off x="0" y="0"/>
            <a:ext cx="22604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7D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E5120915-12B1-4FFA-9B58-7D5547181AEE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5339853" y="755056"/>
            <a:ext cx="5614839" cy="244872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63000A12-F250-4359-8B73-5D0BABA347F5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590482" y="3830716"/>
            <a:ext cx="5364210" cy="244872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xmlns="" id="{9F1665F1-BF9C-8CAF-7C92-3A3B7A2B522F}"/>
              </a:ext>
            </a:extLst>
          </p:cNvPr>
          <p:cNvSpPr txBox="1"/>
          <p:nvPr/>
        </p:nvSpPr>
        <p:spPr>
          <a:xfrm>
            <a:off x="5857782" y="81778"/>
            <a:ext cx="29459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data of MMP-2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xmlns="" id="{21889DD2-5368-BB32-BB3A-784B483781A7}"/>
              </a:ext>
            </a:extLst>
          </p:cNvPr>
          <p:cNvSpPr txBox="1"/>
          <p:nvPr/>
        </p:nvSpPr>
        <p:spPr>
          <a:xfrm>
            <a:off x="5265388" y="2000016"/>
            <a:ext cx="11847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MP-2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23523431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21F6A915-C421-43DD-AC93-A6AC0096E292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4868815" y="498540"/>
            <a:ext cx="7070807" cy="1649855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EB4BF405-BBEB-4134-B379-E238A74BC16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 flipV="1">
            <a:off x="5106338" y="2474385"/>
            <a:ext cx="6623145" cy="1529443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xmlns="" id="{6524B01B-0FC1-400A-9A3C-ACABBF03E577}"/>
              </a:ext>
            </a:extLst>
          </p:cNvPr>
          <p:cNvSpPr txBox="1"/>
          <p:nvPr/>
        </p:nvSpPr>
        <p:spPr>
          <a:xfrm>
            <a:off x="4733720" y="21629"/>
            <a:ext cx="36030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data of β-actin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xmlns="" id="{46CA2DBE-BFC9-4A27-AFE7-0982A9E3869B}"/>
              </a:ext>
            </a:extLst>
          </p:cNvPr>
          <p:cNvSpPr txBox="1"/>
          <p:nvPr/>
        </p:nvSpPr>
        <p:spPr>
          <a:xfrm>
            <a:off x="0" y="0"/>
            <a:ext cx="22604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7D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xmlns="" id="{AE412CB4-1262-448F-80B0-1F28FB5F769F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88776" y="555654"/>
            <a:ext cx="4509586" cy="40740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119868805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A9394752-1B84-4D91-BD63-3790EFB0566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 flipV="1">
            <a:off x="5500862" y="2807921"/>
            <a:ext cx="5975292" cy="1642370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xmlns="" id="{70FDB9A6-BB7B-4CE6-926E-A6288E13496A}"/>
              </a:ext>
            </a:extLst>
          </p:cNvPr>
          <p:cNvSpPr txBox="1"/>
          <p:nvPr/>
        </p:nvSpPr>
        <p:spPr>
          <a:xfrm>
            <a:off x="5550023" y="26971"/>
            <a:ext cx="20862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data of KIF14 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xmlns="" id="{991B1FBC-ED7B-4356-AE06-4EB80DF01914}"/>
              </a:ext>
            </a:extLst>
          </p:cNvPr>
          <p:cNvSpPr txBox="1"/>
          <p:nvPr/>
        </p:nvSpPr>
        <p:spPr>
          <a:xfrm>
            <a:off x="0" y="0"/>
            <a:ext cx="22604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7D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xmlns="" id="{BC1948D7-6E22-43AC-84D1-15DEE57B1D7C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88776" y="555654"/>
            <a:ext cx="4509586" cy="4074053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xmlns="" id="{24FADA80-B5B0-EA65-E3AD-C01F51B9525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201004" y="887320"/>
            <a:ext cx="6470335" cy="17053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3734206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99549CE8-69B9-4A09-9D2F-1535568448B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846423" y="2770968"/>
            <a:ext cx="6551496" cy="1512494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xmlns="" id="{95DC6E7F-2DD6-49DB-AE74-8220A92BDDC5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4644931" y="534200"/>
            <a:ext cx="7492624" cy="1836137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xmlns="" id="{2811F61C-87B4-4098-A132-0B68D7630661}"/>
              </a:ext>
            </a:extLst>
          </p:cNvPr>
          <p:cNvSpPr txBox="1"/>
          <p:nvPr/>
        </p:nvSpPr>
        <p:spPr>
          <a:xfrm>
            <a:off x="20844" y="26971"/>
            <a:ext cx="22604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F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xmlns="" id="{58EE2469-82A8-4474-9859-F2D8F8C7F9B7}"/>
              </a:ext>
            </a:extLst>
          </p:cNvPr>
          <p:cNvSpPr txBox="1"/>
          <p:nvPr/>
        </p:nvSpPr>
        <p:spPr>
          <a:xfrm>
            <a:off x="5052873" y="119555"/>
            <a:ext cx="29459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data of p-AKT(Ser 473)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xmlns="" id="{0DA61091-DA3B-B5FB-84FB-26F95A40F64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19209" y="534200"/>
            <a:ext cx="4355321" cy="36900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5914582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62F6E5CB-464B-48B0-8C57-FF333442F64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 flipV="1">
            <a:off x="5773124" y="3167317"/>
            <a:ext cx="6108873" cy="1324696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xmlns="" id="{404112E1-0FD0-45CA-A5B0-47DDA690DA34}"/>
              </a:ext>
            </a:extLst>
          </p:cNvPr>
          <p:cNvSpPr txBox="1"/>
          <p:nvPr/>
        </p:nvSpPr>
        <p:spPr>
          <a:xfrm>
            <a:off x="0" y="0"/>
            <a:ext cx="22604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7D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xmlns="" id="{A0CE1381-35FD-4D9F-8650-D0089034712D}"/>
              </a:ext>
            </a:extLst>
          </p:cNvPr>
          <p:cNvSpPr txBox="1"/>
          <p:nvPr/>
        </p:nvSpPr>
        <p:spPr>
          <a:xfrm>
            <a:off x="5052677" y="134273"/>
            <a:ext cx="36030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data of p-AKT(Ser473)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xmlns="" id="{2C22C297-3D62-46D8-A788-E0F68AA3EBCB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88776" y="555654"/>
            <a:ext cx="4509586" cy="4074053"/>
          </a:xfrm>
          <a:prstGeom prst="rect">
            <a:avLst/>
          </a:prstGeom>
        </p:spPr>
      </p:pic>
      <p:pic>
        <p:nvPicPr>
          <p:cNvPr id="5" name="图形 4">
            <a:extLst>
              <a:ext uri="{FF2B5EF4-FFF2-40B4-BE49-F238E27FC236}">
                <a16:creationId xmlns:a16="http://schemas.microsoft.com/office/drawing/2014/main" xmlns="" id="{39F324E7-ABBF-418C-BC14-14200086F30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96DAC541-7B7A-43D3-8B79-37D633B846F1}">
                <asvg:svgBlip xmlns:asvg="http://schemas.microsoft.com/office/drawing/2016/SVG/main" xmlns="" r:embed="rId5"/>
              </a:ext>
            </a:extLst>
          </a:blip>
          <a:stretch>
            <a:fillRect/>
          </a:stretch>
        </p:blipFill>
        <p:spPr>
          <a:xfrm>
            <a:off x="5109448" y="1141871"/>
            <a:ext cx="6865230" cy="16332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877021072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6526EE77-A4D8-4BEC-BC84-BC3D2952693D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5406501" y="687267"/>
            <a:ext cx="6785499" cy="1771769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C2EC9898-89AC-4EEE-9C25-DA398D2206A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 flipV="1">
            <a:off x="6205490" y="2354723"/>
            <a:ext cx="5684205" cy="1786730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xmlns="" id="{E711D837-5E1F-4B70-ACF0-DD0A2514F5B1}"/>
              </a:ext>
            </a:extLst>
          </p:cNvPr>
          <p:cNvSpPr txBox="1"/>
          <p:nvPr/>
        </p:nvSpPr>
        <p:spPr>
          <a:xfrm>
            <a:off x="5550023" y="26971"/>
            <a:ext cx="20862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data of AKT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xmlns="" id="{E744B124-79DC-496C-9F29-F1A0CF88EF25}"/>
              </a:ext>
            </a:extLst>
          </p:cNvPr>
          <p:cNvSpPr txBox="1"/>
          <p:nvPr/>
        </p:nvSpPr>
        <p:spPr>
          <a:xfrm>
            <a:off x="0" y="0"/>
            <a:ext cx="22604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7D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xmlns="" id="{DA3ED148-4225-4C5E-A03D-79FA5780A5DF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88776" y="555654"/>
            <a:ext cx="4509586" cy="40740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1264532588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BEBF2673-5AED-4448-A13C-D809340272D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 flipV="1">
            <a:off x="5056638" y="2277123"/>
            <a:ext cx="6586031" cy="2104008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xmlns="" id="{631D3925-B9F1-4312-81C3-E6E235FBE62C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5056638" y="603582"/>
            <a:ext cx="7483137" cy="1873288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xmlns="" id="{89A508CF-30BD-4204-AD8C-2F0133F8A9F5}"/>
              </a:ext>
            </a:extLst>
          </p:cNvPr>
          <p:cNvSpPr txBox="1"/>
          <p:nvPr/>
        </p:nvSpPr>
        <p:spPr>
          <a:xfrm>
            <a:off x="0" y="0"/>
            <a:ext cx="22604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7D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xmlns="" id="{F6911C5F-E77D-4A40-82D0-AA21EA993135}"/>
              </a:ext>
            </a:extLst>
          </p:cNvPr>
          <p:cNvSpPr txBox="1"/>
          <p:nvPr/>
        </p:nvSpPr>
        <p:spPr>
          <a:xfrm>
            <a:off x="5550023" y="26971"/>
            <a:ext cx="20862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data of P27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xmlns="" id="{A6704190-735E-4AB7-901D-83976926E63B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88776" y="555654"/>
            <a:ext cx="4509586" cy="40740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3572706884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782B3A37-C3FC-4212-A075-4516BF28B8FC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5613500" y="636066"/>
            <a:ext cx="5952325" cy="2471117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47DBAB6F-A242-4747-BB32-72A79DF2595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 flipH="1">
            <a:off x="6000351" y="3429000"/>
            <a:ext cx="5362259" cy="223939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EC723BB6-9957-4AD7-A2AE-04B52E528D37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88776" y="555654"/>
            <a:ext cx="4509586" cy="4074053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xmlns="" id="{139A882E-38C7-4357-BCF1-5ECF51AB106F}"/>
              </a:ext>
            </a:extLst>
          </p:cNvPr>
          <p:cNvSpPr txBox="1"/>
          <p:nvPr/>
        </p:nvSpPr>
        <p:spPr>
          <a:xfrm>
            <a:off x="0" y="0"/>
            <a:ext cx="22604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7D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xmlns="" id="{24C6BCDB-97BC-7304-29E1-9143FA96741B}"/>
              </a:ext>
            </a:extLst>
          </p:cNvPr>
          <p:cNvSpPr txBox="1"/>
          <p:nvPr/>
        </p:nvSpPr>
        <p:spPr>
          <a:xfrm>
            <a:off x="5857782" y="81778"/>
            <a:ext cx="29459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data of MMP-2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737300658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718B1F95-DCBB-4084-A6C0-5DDFFFB99DE7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4841694" y="738910"/>
            <a:ext cx="6867226" cy="2036974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8E8FE61E-FEA3-493D-9A19-B944097292D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 flipV="1">
            <a:off x="5309713" y="2998687"/>
            <a:ext cx="6179761" cy="1937294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xmlns="" id="{F2D93F0C-5150-43BA-8189-39C1B157A28C}"/>
              </a:ext>
            </a:extLst>
          </p:cNvPr>
          <p:cNvSpPr txBox="1"/>
          <p:nvPr/>
        </p:nvSpPr>
        <p:spPr>
          <a:xfrm>
            <a:off x="5646197" y="177553"/>
            <a:ext cx="19900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data of β-actin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xmlns="" id="{03B605D3-65C4-4946-8747-5D1154B7DE5E}"/>
              </a:ext>
            </a:extLst>
          </p:cNvPr>
          <p:cNvSpPr txBox="1"/>
          <p:nvPr/>
        </p:nvSpPr>
        <p:spPr>
          <a:xfrm>
            <a:off x="0" y="0"/>
            <a:ext cx="22604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7D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xmlns="" id="{3C8722B6-9590-444C-B124-87577175911E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88776" y="555654"/>
            <a:ext cx="4509586" cy="40740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4296018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xmlns="" id="{E26F59D7-A6F6-757A-35D6-549AB357F0D3}"/>
              </a:ext>
            </a:extLst>
          </p:cNvPr>
          <p:cNvSpPr txBox="1"/>
          <p:nvPr/>
        </p:nvSpPr>
        <p:spPr>
          <a:xfrm>
            <a:off x="54500" y="66611"/>
            <a:ext cx="3869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Supplemental Figure 6A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7DD6F115-FC7A-20A3-5E64-FFA4C6D12B1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90948" y="691101"/>
            <a:ext cx="5167192" cy="2641009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xmlns="" id="{78467BDC-7C36-027A-2C75-C01D2267389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 flipH="1" flipV="1">
            <a:off x="5987327" y="3226997"/>
            <a:ext cx="5647574" cy="1967135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xmlns="" id="{734A3190-DF0B-C8A7-3117-5059A1901AA9}"/>
              </a:ext>
            </a:extLst>
          </p:cNvPr>
          <p:cNvSpPr txBox="1"/>
          <p:nvPr/>
        </p:nvSpPr>
        <p:spPr>
          <a:xfrm>
            <a:off x="5857782" y="81778"/>
            <a:ext cx="29459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data of Ago2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xmlns="" id="{C71985AC-4925-36CF-8FA9-F38AB368B8E0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690426" y="853993"/>
            <a:ext cx="6241377" cy="21900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11339403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xmlns="" id="{B338AE75-CF25-8D22-0996-DED55EC92CD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xmlns="" id="{C893BD16-A149-09F7-7D51-036670F945C2}"/>
              </a:ext>
            </a:extLst>
          </p:cNvPr>
          <p:cNvSpPr txBox="1"/>
          <p:nvPr/>
        </p:nvSpPr>
        <p:spPr>
          <a:xfrm>
            <a:off x="54500" y="66611"/>
            <a:ext cx="3869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Supplemental Figure 6A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A187B586-098B-F09F-2FCE-313C87B8978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90948" y="691101"/>
            <a:ext cx="5167192" cy="2641009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5BE48E51-1588-0A88-0C30-D09BAD18CCF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541784" y="594416"/>
            <a:ext cx="6359269" cy="1985281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xmlns="" id="{6CAE7AE6-42B4-AC58-92E0-BB14CFFEAE8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 flipH="1" flipV="1">
            <a:off x="5829317" y="3058935"/>
            <a:ext cx="5612976" cy="1877872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xmlns="" id="{7EA42964-C8EE-9435-6367-44D627897AD1}"/>
              </a:ext>
            </a:extLst>
          </p:cNvPr>
          <p:cNvSpPr txBox="1"/>
          <p:nvPr/>
        </p:nvSpPr>
        <p:spPr>
          <a:xfrm>
            <a:off x="5857782" y="81778"/>
            <a:ext cx="29459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data of β-actin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3831382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xmlns="" id="{2AE96B9D-285A-27A8-7BBB-307FEE6AF41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09115" y="672935"/>
            <a:ext cx="4833156" cy="2470280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xmlns="" id="{78662244-5EF2-1FC8-E23E-9AE41FE7D160}"/>
              </a:ext>
            </a:extLst>
          </p:cNvPr>
          <p:cNvSpPr txBox="1"/>
          <p:nvPr/>
        </p:nvSpPr>
        <p:spPr>
          <a:xfrm>
            <a:off x="54500" y="66611"/>
            <a:ext cx="3869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Supplemental Figure 6A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B71E480D-194D-AB04-D0B9-752727AF95B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595107" y="508315"/>
            <a:ext cx="6287778" cy="208742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54FF919E-8341-194A-D46D-07A0BCBE482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 flipH="1" flipV="1">
            <a:off x="5595107" y="2813593"/>
            <a:ext cx="5760203" cy="1606253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xmlns="" id="{A8FC200E-C5B6-566A-5C80-6A9AA6583200}"/>
              </a:ext>
            </a:extLst>
          </p:cNvPr>
          <p:cNvSpPr txBox="1"/>
          <p:nvPr/>
        </p:nvSpPr>
        <p:spPr>
          <a:xfrm>
            <a:off x="5857782" y="81778"/>
            <a:ext cx="29459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data of Ago2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713759650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xmlns="" id="{874AEBA5-A125-E6BB-129D-C83A6AB7FF8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64781" y="527307"/>
            <a:ext cx="4941411" cy="2525610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xmlns="" id="{4A458B3D-192A-F069-A1DB-B70F82C961D3}"/>
              </a:ext>
            </a:extLst>
          </p:cNvPr>
          <p:cNvSpPr txBox="1"/>
          <p:nvPr/>
        </p:nvSpPr>
        <p:spPr>
          <a:xfrm>
            <a:off x="54500" y="66611"/>
            <a:ext cx="3869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Supplemental Figure 6A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xmlns="" id="{91ACF5C9-1285-6D5B-290B-29CBF12084EF}"/>
              </a:ext>
            </a:extLst>
          </p:cNvPr>
          <p:cNvSpPr txBox="1"/>
          <p:nvPr/>
        </p:nvSpPr>
        <p:spPr>
          <a:xfrm>
            <a:off x="5857782" y="81778"/>
            <a:ext cx="29459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data of β-actin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xmlns="" id="{EB7B3969-C827-415F-D8F2-E25F867C3D5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545528" y="770604"/>
            <a:ext cx="5571228" cy="193204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xmlns="" id="{ED49635F-26E5-BA6C-F1AE-EF6D835B1149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 flipH="1">
            <a:off x="6096000" y="3097162"/>
            <a:ext cx="4714434" cy="1628996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458FECB7-C8A2-8BF7-C628-84EDD9ED9D9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516031" y="760771"/>
            <a:ext cx="5571228" cy="1932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16015125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FA45F58F-FBBC-4980-B641-2454C929B85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 flipV="1">
            <a:off x="5435549" y="2597961"/>
            <a:ext cx="6569639" cy="1804424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xmlns="" id="{A308CAFA-63B9-460F-B3F4-697AA7674B2B}"/>
              </a:ext>
            </a:extLst>
          </p:cNvPr>
          <p:cNvSpPr txBox="1"/>
          <p:nvPr/>
        </p:nvSpPr>
        <p:spPr>
          <a:xfrm>
            <a:off x="5416857" y="58685"/>
            <a:ext cx="29459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data of AKT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xmlns="" id="{EF7E3CEC-DB5F-4CC8-B758-0B55095A1BF5}"/>
              </a:ext>
            </a:extLst>
          </p:cNvPr>
          <p:cNvSpPr txBox="1"/>
          <p:nvPr/>
        </p:nvSpPr>
        <p:spPr>
          <a:xfrm>
            <a:off x="20844" y="26971"/>
            <a:ext cx="22604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F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xmlns="" id="{BB00A0B1-9CCC-B7E2-C23D-4338FB35FD2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33957" y="545928"/>
            <a:ext cx="4355321" cy="3690032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A0D46DA3-7180-D2CD-26AF-AB6AB4495BB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190256" y="661068"/>
            <a:ext cx="6481810" cy="18478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15155063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E833E49B-915D-4C70-A6D4-18BEA9502853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5282213" y="790588"/>
            <a:ext cx="6616823" cy="1281891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08F2EACB-4923-456E-8C9E-EA802B893AC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 flipV="1">
            <a:off x="5750931" y="2664677"/>
            <a:ext cx="6325660" cy="124429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xmlns="" id="{E762CA96-A64D-41DE-8652-B5052237C182}"/>
              </a:ext>
            </a:extLst>
          </p:cNvPr>
          <p:cNvSpPr txBox="1"/>
          <p:nvPr/>
        </p:nvSpPr>
        <p:spPr>
          <a:xfrm>
            <a:off x="5857782" y="81778"/>
            <a:ext cx="29459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data of P27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xmlns="" id="{82A15643-C038-4E48-B53D-12D3AC3E0470}"/>
              </a:ext>
            </a:extLst>
          </p:cNvPr>
          <p:cNvSpPr txBox="1"/>
          <p:nvPr/>
        </p:nvSpPr>
        <p:spPr>
          <a:xfrm>
            <a:off x="20844" y="26971"/>
            <a:ext cx="22604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F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xmlns="" id="{DB28139A-72BD-6D90-F5DC-87BBB8667015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92964" y="565593"/>
            <a:ext cx="4355321" cy="36900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11051640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xmlns="" id="{64E37D66-C340-45C8-9761-E2B46034DD20}"/>
              </a:ext>
            </a:extLst>
          </p:cNvPr>
          <p:cNvSpPr txBox="1"/>
          <p:nvPr/>
        </p:nvSpPr>
        <p:spPr>
          <a:xfrm>
            <a:off x="20844" y="26971"/>
            <a:ext cx="22604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F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C643BA3F-E5C7-45FC-BFCB-355141672C47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4772167" y="668193"/>
            <a:ext cx="6689438" cy="2447869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E0E1F8E8-D8CB-48CA-8F5D-F7418E00812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 flipV="1">
            <a:off x="5442011" y="3116062"/>
            <a:ext cx="6326650" cy="2565497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xmlns="" id="{4E02DF14-3E8B-75AC-C3C6-4B2C8ABAC4E8}"/>
              </a:ext>
            </a:extLst>
          </p:cNvPr>
          <p:cNvSpPr txBox="1"/>
          <p:nvPr/>
        </p:nvSpPr>
        <p:spPr>
          <a:xfrm>
            <a:off x="5857782" y="81778"/>
            <a:ext cx="29459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data of MMP-2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xmlns="" id="{EA04F059-661F-E65E-66BB-7BAC8EE43884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33957" y="545928"/>
            <a:ext cx="4355321" cy="36900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35746730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E414C8FA-5DF3-4CEE-B342-1E4B56CE4E0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 flipH="1">
            <a:off x="4009226" y="3429000"/>
            <a:ext cx="6511936" cy="1703755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xmlns="" id="{12B0451F-6C3F-4949-BC35-BA84B779C2CB}"/>
              </a:ext>
            </a:extLst>
          </p:cNvPr>
          <p:cNvSpPr txBox="1"/>
          <p:nvPr/>
        </p:nvSpPr>
        <p:spPr>
          <a:xfrm>
            <a:off x="5857782" y="81778"/>
            <a:ext cx="29459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data of β-actin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xmlns="" id="{68F90FC9-EF43-46D0-B809-5BF70569A7D8}"/>
              </a:ext>
            </a:extLst>
          </p:cNvPr>
          <p:cNvSpPr txBox="1"/>
          <p:nvPr/>
        </p:nvSpPr>
        <p:spPr>
          <a:xfrm>
            <a:off x="20844" y="26971"/>
            <a:ext cx="22604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F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xmlns="" id="{5D9B9451-84CD-1602-8368-995CD28A905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665896" y="810992"/>
            <a:ext cx="6024508" cy="1800938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xmlns="" id="{BCD16D5B-0BA4-4EDC-AB22-12AE44D4D05C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50383" y="541012"/>
            <a:ext cx="4355321" cy="36900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63694815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784B4BD0-9880-48A6-8AFF-D604CFC3A69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 flipV="1">
            <a:off x="6243448" y="1885598"/>
            <a:ext cx="5797229" cy="2532398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xmlns="" id="{23B69763-5A34-4810-BE7B-17237E441D92}"/>
              </a:ext>
            </a:extLst>
          </p:cNvPr>
          <p:cNvSpPr txBox="1"/>
          <p:nvPr/>
        </p:nvSpPr>
        <p:spPr>
          <a:xfrm>
            <a:off x="6251359" y="79563"/>
            <a:ext cx="20862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data of KIF14 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xmlns="" id="{D9D3C1A2-823D-450E-A2D8-C4A5CF7EBAE9}"/>
              </a:ext>
            </a:extLst>
          </p:cNvPr>
          <p:cNvSpPr txBox="1"/>
          <p:nvPr/>
        </p:nvSpPr>
        <p:spPr>
          <a:xfrm>
            <a:off x="20844" y="26971"/>
            <a:ext cx="22604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F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xmlns="" id="{C329AFE3-CA1B-55B9-7A65-7B6EAC6832F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 flipV="1">
            <a:off x="5948553" y="2735154"/>
            <a:ext cx="5797229" cy="2532398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xmlns="" id="{E9B4045D-3E04-E411-FCBB-FCA135289B7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965146" y="863133"/>
            <a:ext cx="6744929" cy="1935930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xmlns="" id="{7A85B585-4439-6295-26BD-15533A953E9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19209" y="541012"/>
            <a:ext cx="4355321" cy="36900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323875194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AD04B7C2-8459-4A7C-B7B4-015655D47283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5450890" y="810000"/>
            <a:ext cx="6483371" cy="1711257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89291F82-65B6-41D2-85F7-EDBBE26557E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 flipV="1">
            <a:off x="6329071" y="3129083"/>
            <a:ext cx="5862929" cy="1431169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xmlns="" id="{CB783B39-2792-4AF0-ADD7-34B3F105D815}"/>
              </a:ext>
            </a:extLst>
          </p:cNvPr>
          <p:cNvSpPr txBox="1"/>
          <p:nvPr/>
        </p:nvSpPr>
        <p:spPr>
          <a:xfrm>
            <a:off x="6251358" y="79563"/>
            <a:ext cx="27239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data of p-AKT(Ser 473)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xmlns="" id="{98AD1611-BE2C-4202-B7D9-3A7329A0FB3E}"/>
              </a:ext>
            </a:extLst>
          </p:cNvPr>
          <p:cNvSpPr txBox="1"/>
          <p:nvPr/>
        </p:nvSpPr>
        <p:spPr>
          <a:xfrm>
            <a:off x="20844" y="26971"/>
            <a:ext cx="22604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F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xmlns="" id="{837B1611-8473-D408-0CA4-FA7D2D5A2ED9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19208" y="531179"/>
            <a:ext cx="4355321" cy="36900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53786140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3CC769D2-A947-4BA0-8EFF-AE97FC7988B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 flipH="1">
            <a:off x="4758285" y="3380541"/>
            <a:ext cx="6219716" cy="1684347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xmlns="" id="{1EE3AEA5-8EE5-4A97-A5B7-3EB26D368E86}"/>
              </a:ext>
            </a:extLst>
          </p:cNvPr>
          <p:cNvSpPr txBox="1"/>
          <p:nvPr/>
        </p:nvSpPr>
        <p:spPr>
          <a:xfrm>
            <a:off x="6251358" y="79563"/>
            <a:ext cx="27239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data of AKT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xmlns="" id="{4A481146-3B6C-440D-B894-A282C2FF196A}"/>
              </a:ext>
            </a:extLst>
          </p:cNvPr>
          <p:cNvSpPr txBox="1"/>
          <p:nvPr/>
        </p:nvSpPr>
        <p:spPr>
          <a:xfrm>
            <a:off x="20844" y="26971"/>
            <a:ext cx="22604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F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xmlns="" id="{B4C51493-E465-3202-F4CC-9478CE52FC8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991187" y="1014428"/>
            <a:ext cx="5881731" cy="1566874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xmlns="" id="{70DD06D3-4A8A-D52B-D22A-7C71E2713140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19209" y="545928"/>
            <a:ext cx="4355321" cy="36900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20971355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2</TotalTime>
  <Words>179</Words>
  <Application>Microsoft Office PowerPoint</Application>
  <PresentationFormat>自定义</PresentationFormat>
  <Paragraphs>57</Paragraphs>
  <Slides>28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8</vt:i4>
      </vt:variant>
    </vt:vector>
  </HeadingPairs>
  <TitlesOfParts>
    <vt:vector size="29" baseType="lpstr">
      <vt:lpstr>WPS</vt:lpstr>
      <vt:lpstr>幻灯片 1</vt:lpstr>
      <vt:lpstr>幻灯片 2</vt:lpstr>
      <vt:lpstr>幻灯片 3</vt:lpstr>
      <vt:lpstr>幻灯片 4</vt:lpstr>
      <vt:lpstr>幻灯片 5</vt:lpstr>
      <vt:lpstr>幻灯片 6</vt:lpstr>
      <vt:lpstr>幻灯片 7</vt:lpstr>
      <vt:lpstr>幻灯片 8</vt:lpstr>
      <vt:lpstr>幻灯片 9</vt:lpstr>
      <vt:lpstr>幻灯片 10</vt:lpstr>
      <vt:lpstr>幻灯片 11</vt:lpstr>
      <vt:lpstr>幻灯片 12</vt:lpstr>
      <vt:lpstr>幻灯片 13</vt:lpstr>
      <vt:lpstr>幻灯片 14</vt:lpstr>
      <vt:lpstr>幻灯片 15</vt:lpstr>
      <vt:lpstr>幻灯片 16</vt:lpstr>
      <vt:lpstr>幻灯片 17</vt:lpstr>
      <vt:lpstr>幻灯片 18</vt:lpstr>
      <vt:lpstr>幻灯片 19</vt:lpstr>
      <vt:lpstr>幻灯片 20</vt:lpstr>
      <vt:lpstr>幻灯片 21</vt:lpstr>
      <vt:lpstr>幻灯片 22</vt:lpstr>
      <vt:lpstr>幻灯片 23</vt:lpstr>
      <vt:lpstr>幻灯片 24</vt:lpstr>
      <vt:lpstr>幻灯片 25</vt:lpstr>
      <vt:lpstr>幻灯片 26</vt:lpstr>
      <vt:lpstr>幻灯片 27</vt:lpstr>
      <vt:lpstr>幻灯片 28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ELL</dc:creator>
  <cp:lastModifiedBy>A</cp:lastModifiedBy>
  <cp:revision>99</cp:revision>
  <dcterms:created xsi:type="dcterms:W3CDTF">2023-08-09T12:44:55Z</dcterms:created>
  <dcterms:modified xsi:type="dcterms:W3CDTF">2025-05-12T13:48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B0086CAF875411CACBDA13AB9801EF4_13</vt:lpwstr>
  </property>
  <property fmtid="{D5CDD505-2E9C-101B-9397-08002B2CF9AE}" pid="3" name="KSOProductBuildVer">
    <vt:lpwstr>2052-12.1.0.15259</vt:lpwstr>
  </property>
</Properties>
</file>